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  <p:sldId id="256" r:id="rId3"/>
    <p:sldId id="257" r:id="rId4"/>
    <p:sldId id="272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75DCB02-9BB8-47FD-8907-85C794F793BA}" styleName="Themed Style 1 - Accent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995" autoAdjust="0"/>
    <p:restoredTop sz="94660"/>
  </p:normalViewPr>
  <p:slideViewPr>
    <p:cSldViewPr snapToGrid="0">
      <p:cViewPr varScale="1">
        <p:scale>
          <a:sx n="49" d="100"/>
          <a:sy n="49" d="100"/>
        </p:scale>
        <p:origin x="2148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063215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39538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571747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969779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3427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8136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162574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625596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5299799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191031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030681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1F92C-A0FE-464E-85C1-D3A490D70CA3}" type="datetimeFigureOut">
              <a:rPr lang="th-TH" smtClean="0"/>
              <a:t>21/09/65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9420C-01E0-40B6-B264-71E469265434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9828482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FE1AC7A-E7A7-403E-8ADB-43529B0BBA01}"/>
              </a:ext>
            </a:extLst>
          </p:cNvPr>
          <p:cNvSpPr txBox="1"/>
          <p:nvPr/>
        </p:nvSpPr>
        <p:spPr>
          <a:xfrm>
            <a:off x="137766" y="309098"/>
            <a:ext cx="658246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</a:rPr>
              <a:t>Supplementary Figure 1.	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ces protein expression of 6-signature genes in 						cholangiocarcinoma tissues and normal tissues from Human Protein Atlas. </a:t>
            </a:r>
            <a:endParaRPr lang="th-TH" sz="1200" dirty="0">
              <a:latin typeface="Times New Roman" panose="02020603050405020304" pitchFamily="18" charset="0"/>
            </a:endParaRPr>
          </a:p>
          <a:p>
            <a:pPr algn="ctr"/>
            <a:endParaRPr lang="th-TH" sz="1200" dirty="0">
              <a:latin typeface="Times New Roman" panose="02020603050405020304" pitchFamily="18" charset="0"/>
            </a:endParaRPr>
          </a:p>
        </p:txBody>
      </p:sp>
      <p:pic>
        <p:nvPicPr>
          <p:cNvPr id="9" name="Picture 8" descr="Diagram&#10;&#10;Description automatically generated with medium confidence">
            <a:extLst>
              <a:ext uri="{FF2B5EF4-FFF2-40B4-BE49-F238E27FC236}">
                <a16:creationId xmlns:a16="http://schemas.microsoft.com/office/drawing/2014/main" id="{737BF8F1-508E-5528-E636-11FC233163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494" y="1183404"/>
            <a:ext cx="6047011" cy="78854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7504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2A88AAC6-7F3F-2C71-BA05-BA9A53A535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5404212"/>
              </p:ext>
            </p:extLst>
          </p:nvPr>
        </p:nvGraphicFramePr>
        <p:xfrm>
          <a:off x="130702" y="876054"/>
          <a:ext cx="6596595" cy="8153892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364742">
                  <a:extLst>
                    <a:ext uri="{9D8B030D-6E8A-4147-A177-3AD203B41FA5}">
                      <a16:colId xmlns:a16="http://schemas.microsoft.com/office/drawing/2014/main" val="1117979045"/>
                    </a:ext>
                  </a:extLst>
                </a:gridCol>
                <a:gridCol w="971868">
                  <a:extLst>
                    <a:ext uri="{9D8B030D-6E8A-4147-A177-3AD203B41FA5}">
                      <a16:colId xmlns:a16="http://schemas.microsoft.com/office/drawing/2014/main" val="1851633781"/>
                    </a:ext>
                  </a:extLst>
                </a:gridCol>
                <a:gridCol w="980948">
                  <a:extLst>
                    <a:ext uri="{9D8B030D-6E8A-4147-A177-3AD203B41FA5}">
                      <a16:colId xmlns:a16="http://schemas.microsoft.com/office/drawing/2014/main" val="4009038722"/>
                    </a:ext>
                  </a:extLst>
                </a:gridCol>
                <a:gridCol w="1171702">
                  <a:extLst>
                    <a:ext uri="{9D8B030D-6E8A-4147-A177-3AD203B41FA5}">
                      <a16:colId xmlns:a16="http://schemas.microsoft.com/office/drawing/2014/main" val="1022663786"/>
                    </a:ext>
                  </a:extLst>
                </a:gridCol>
                <a:gridCol w="979805">
                  <a:extLst>
                    <a:ext uri="{9D8B030D-6E8A-4147-A177-3AD203B41FA5}">
                      <a16:colId xmlns:a16="http://schemas.microsoft.com/office/drawing/2014/main" val="3132964759"/>
                    </a:ext>
                  </a:extLst>
                </a:gridCol>
                <a:gridCol w="1127530">
                  <a:extLst>
                    <a:ext uri="{9D8B030D-6E8A-4147-A177-3AD203B41FA5}">
                      <a16:colId xmlns:a16="http://schemas.microsoft.com/office/drawing/2014/main" val="1137716440"/>
                    </a:ext>
                  </a:extLst>
                </a:gridCol>
              </a:tblGrid>
              <a:tr h="360604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aracteristics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E89749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EP001105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-MTAB-6389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SE107943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GA-CHOL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8979525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7769753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≤ 60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5.86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6.31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0.00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9.39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887196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&gt; 60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4.14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3.69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70.00%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0.61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5001930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943540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Femal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5.05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6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3.44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1.28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0.00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7.58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819341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Mal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4.95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8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6.56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8.72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0.00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2.42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71315958"/>
                  </a:ext>
                </a:extLst>
              </a:tr>
              <a:tr h="452688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ge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320665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2.61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1.97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0.00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4.55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581264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I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5.32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1.15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0.00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4.24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187509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II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3.42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1.56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33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03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0262184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IV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6.04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.33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6.67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8.18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4810377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uke infection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14439939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Negativ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5.86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9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3.85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5034812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Positiv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4.14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.15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801786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scular invasion</a:t>
                      </a:r>
                      <a:endParaRPr lang="th-TH" sz="1200" b="1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R>
                      <a:noFill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3932257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No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7.79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4.62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0.00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>
                    <a:lnT>
                      <a:noFill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00519894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Yes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2.21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65.38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0.00%)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6794235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57150925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2CCC1D8-EE87-7DBC-4DAD-EE01C54740AB}"/>
              </a:ext>
            </a:extLst>
          </p:cNvPr>
          <p:cNvSpPr txBox="1"/>
          <p:nvPr/>
        </p:nvSpPr>
        <p:spPr>
          <a:xfrm>
            <a:off x="167310" y="218364"/>
            <a:ext cx="4800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 Table 1. The characteristics of CCA patients in all datasets </a:t>
            </a:r>
            <a:endParaRPr lang="th-TH" sz="1200" dirty="0"/>
          </a:p>
        </p:txBody>
      </p:sp>
    </p:spTree>
    <p:extLst>
      <p:ext uri="{BB962C8B-B14F-4D97-AF65-F5344CB8AC3E}">
        <p14:creationId xmlns:p14="http://schemas.microsoft.com/office/powerpoint/2010/main" val="31009559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8D6E2FE-A77C-8CE2-0A53-00974EA9AE66}"/>
              </a:ext>
            </a:extLst>
          </p:cNvPr>
          <p:cNvSpPr txBox="1"/>
          <p:nvPr/>
        </p:nvSpPr>
        <p:spPr>
          <a:xfrm>
            <a:off x="167310" y="218364"/>
            <a:ext cx="41156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 Table 2. The sequences of primers for RT-qPCR.</a:t>
            </a:r>
            <a:endParaRPr lang="th-TH" sz="1200" dirty="0"/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B35BB451-3D7F-DF04-8E00-AD8CD70461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1598532"/>
              </p:ext>
            </p:extLst>
          </p:nvPr>
        </p:nvGraphicFramePr>
        <p:xfrm>
          <a:off x="1207318" y="1054290"/>
          <a:ext cx="4729458" cy="556260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857307">
                  <a:extLst>
                    <a:ext uri="{9D8B030D-6E8A-4147-A177-3AD203B41FA5}">
                      <a16:colId xmlns:a16="http://schemas.microsoft.com/office/drawing/2014/main" val="776811012"/>
                    </a:ext>
                  </a:extLst>
                </a:gridCol>
                <a:gridCol w="2872151">
                  <a:extLst>
                    <a:ext uri="{9D8B030D-6E8A-4147-A177-3AD203B41FA5}">
                      <a16:colId xmlns:a16="http://schemas.microsoft.com/office/drawing/2014/main" val="336391267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5’ to 3’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4104689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B Forward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AGAGCTACGAGCTGCCTGAC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416866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B Revers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AGCACTGTGTTGGCGTACAG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7993885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1 Forward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AGGCACCACAGACTATCCA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81953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O1 Revers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AGGTTACTGCGGTGAATGC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400447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NCD2 Forward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AACTGGTTCCGAGAGATTGT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143807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NCD2 Revers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CCACATCAAAGTTTCCAAGAGG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838802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T1 Forward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AAGGAGAAGCGGGTAGGAG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1860235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OT1 Revers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GCATCCCAGTAGCGATAGG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1863061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GS2 Forward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AAATTGCTGGCAGGGTTGC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18979384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TGS2 Revers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AGGGCTTCAGCATAAAGCGT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301241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2A1 Forward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TTCACTGTCGTGTCGCTGT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5117263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LC2A1 Revers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CCACTTCAAAGAAGGCCAC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1443299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LE Forward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GTGCTGGTGTTCCTCTCG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6508749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LE Reverse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TGGTTCCTTTTCTGCGCCTC</a:t>
                      </a:r>
                      <a:endParaRPr lang="th-TH" sz="1200" dirty="0">
                        <a:latin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98870806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569016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9B6D2554-C4AE-2546-4925-6129F71528A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0856318"/>
              </p:ext>
            </p:extLst>
          </p:nvPr>
        </p:nvGraphicFramePr>
        <p:xfrm>
          <a:off x="99555" y="1662492"/>
          <a:ext cx="6658890" cy="7105005"/>
        </p:xfrm>
        <a:graphic>
          <a:graphicData uri="http://schemas.openxmlformats.org/drawingml/2006/table">
            <a:tbl>
              <a:tblPr bandRow="1">
                <a:tableStyleId>{8EC20E35-A176-4012-BC5E-935CFFF8708E}</a:tableStyleId>
              </a:tblPr>
              <a:tblGrid>
                <a:gridCol w="1108800">
                  <a:extLst>
                    <a:ext uri="{9D8B030D-6E8A-4147-A177-3AD203B41FA5}">
                      <a16:colId xmlns:a16="http://schemas.microsoft.com/office/drawing/2014/main" val="203484549"/>
                    </a:ext>
                  </a:extLst>
                </a:gridCol>
                <a:gridCol w="1110018">
                  <a:extLst>
                    <a:ext uri="{9D8B030D-6E8A-4147-A177-3AD203B41FA5}">
                      <a16:colId xmlns:a16="http://schemas.microsoft.com/office/drawing/2014/main" val="2760810484"/>
                    </a:ext>
                  </a:extLst>
                </a:gridCol>
                <a:gridCol w="1110018">
                  <a:extLst>
                    <a:ext uri="{9D8B030D-6E8A-4147-A177-3AD203B41FA5}">
                      <a16:colId xmlns:a16="http://schemas.microsoft.com/office/drawing/2014/main" val="2411551426"/>
                    </a:ext>
                  </a:extLst>
                </a:gridCol>
                <a:gridCol w="1110018">
                  <a:extLst>
                    <a:ext uri="{9D8B030D-6E8A-4147-A177-3AD203B41FA5}">
                      <a16:colId xmlns:a16="http://schemas.microsoft.com/office/drawing/2014/main" val="1575094172"/>
                    </a:ext>
                  </a:extLst>
                </a:gridCol>
                <a:gridCol w="1110018">
                  <a:extLst>
                    <a:ext uri="{9D8B030D-6E8A-4147-A177-3AD203B41FA5}">
                      <a16:colId xmlns:a16="http://schemas.microsoft.com/office/drawing/2014/main" val="2981635605"/>
                    </a:ext>
                  </a:extLst>
                </a:gridCol>
                <a:gridCol w="1110018">
                  <a:extLst>
                    <a:ext uri="{9D8B030D-6E8A-4147-A177-3AD203B41FA5}">
                      <a16:colId xmlns:a16="http://schemas.microsoft.com/office/drawing/2014/main" val="428221539"/>
                    </a:ext>
                  </a:extLst>
                </a:gridCol>
              </a:tblGrid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ABCC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CARS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6PDX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INC003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RA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NORA16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4993729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AC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V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ABARAPL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INC004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OTUB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NX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7201804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O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B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GABARAPL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OC2845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OXSR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OCS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0594237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SF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D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ABPB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OC3907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ANX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0884066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SL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DKN1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CH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ON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CK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QL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7811424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SL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DKN2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CL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PCAT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EB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QSTM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1393084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CVR1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CDO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CL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PIN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G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R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2981727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GPAT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EBP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DF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LURAP1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HKG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RXN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5185749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IFM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AC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LS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F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IK3C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TAT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2301088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KR1C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MP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LUT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P1LC3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LIN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TEAP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7687557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KR1C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HMP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OT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P3K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LIN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TMN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3582151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KR1C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ISD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PT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PK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M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AZ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9839512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ISD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PX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PK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DX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F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9939524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OX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RYA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PX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PK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DX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FAP2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1197918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OX12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GS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PK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KAA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FR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0844678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OX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XCL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AMP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APK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KAA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FR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917171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OX15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YB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HBA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OX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ROM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GFBR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1076283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OX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DIT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LL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R1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SAT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LR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26946221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LOXE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DIT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ERPUD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R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PTGS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MBIM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45029099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NGPTL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NAJB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IC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R2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B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NFAIP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5639830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NO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PP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IF1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R30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EL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P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2439065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RNT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RD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ILPD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R471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GS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P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4107017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RRDC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RD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MGB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R68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IPK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RIB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6995399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SN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UOX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MGC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R9-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PL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SC22D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4995371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F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UOX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MOX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R9-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RRM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UBE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587022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F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DUS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NF4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IR9-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AT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XNIP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0016734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G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GF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RA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T1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C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TXNRD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7799424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G16L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GLN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SB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T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C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UBC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692819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G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IF2AK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SD17B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TD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LENO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ULK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8239483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G4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IF2S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SF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TO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SN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ULK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1547364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G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LAVL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SPA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UC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ETD1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DAC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18301274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G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MC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HSPB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MY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IRT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EGF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50909013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M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NP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DH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CF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1A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VLDL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7626460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5MC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EPAS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FN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COA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1A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WIPI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8045834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TP6V1G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DS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L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F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2A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WIPI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6720477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AURKA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ANCD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L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FE2L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2A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XB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6747330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ACH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BXW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REB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FS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2A1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YWHA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26063762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A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DFT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ISCU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G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2A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YY1A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1804034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ECN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er1HC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JDP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NM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2A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ZEB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50110997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I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H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JU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OS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2A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ZFP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1854764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BLOC1S5-TXNDC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LT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EAP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OX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38A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ZFP69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0452156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NIP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TH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IM-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OX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3A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ZNF4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1228647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BRD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T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LHL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OX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40A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th-TH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95166955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CA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FTM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KRA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NOX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>
                          <a:effectLst/>
                        </a:rPr>
                        <a:t>SLC7A1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th-TH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8235396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CAP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G6PD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LAMP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NQO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</a:rPr>
                        <a:t>SLC7A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th-TH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5489" marR="5489" marT="548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72425248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B3C98C70-6106-1BB8-429E-F321D3A0BC46}"/>
              </a:ext>
            </a:extLst>
          </p:cNvPr>
          <p:cNvSpPr txBox="1"/>
          <p:nvPr/>
        </p:nvSpPr>
        <p:spPr>
          <a:xfrm>
            <a:off x="167310" y="218364"/>
            <a:ext cx="3656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 Table 3. List of ferroptosis-related genes</a:t>
            </a:r>
            <a:endParaRPr lang="th-TH" sz="1200" dirty="0"/>
          </a:p>
        </p:txBody>
      </p:sp>
    </p:spTree>
    <p:extLst>
      <p:ext uri="{BB962C8B-B14F-4D97-AF65-F5344CB8AC3E}">
        <p14:creationId xmlns:p14="http://schemas.microsoft.com/office/powerpoint/2010/main" val="35735499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7</TotalTime>
  <Words>596</Words>
  <Application>Microsoft Office PowerPoint</Application>
  <PresentationFormat>A4 Paper (210x297 mm)</PresentationFormat>
  <Paragraphs>42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Cordia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piwit Sae-fung</dc:creator>
  <cp:lastModifiedBy>Siriporn Jitkaew</cp:lastModifiedBy>
  <cp:revision>15</cp:revision>
  <dcterms:created xsi:type="dcterms:W3CDTF">2022-06-01T11:10:54Z</dcterms:created>
  <dcterms:modified xsi:type="dcterms:W3CDTF">2022-09-22T01:49:56Z</dcterms:modified>
</cp:coreProperties>
</file>